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FD2249-4260-463B-99A2-7A3D8C5C365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9BD69D-F8DA-48A4-9350-EECEF4CB73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575EF9-708A-481C-8B88-BD0CDC78B6D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83A140-0A5C-4ACE-B685-0C1F9257276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0E9EFF-560B-4FE8-A74C-A82FB66D8E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641D15-AFAD-4198-80EE-936CD10DA0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E73060-AD0D-483A-8638-6B7CEED3E9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099F22-AD95-4C3A-A585-FC5F99B91EB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302001-A05B-448B-A352-0DB9962E12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628B87-B1FC-49C3-8A9E-36470868A5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F522B7-275A-4A06-94F4-7C18905522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F74B0E-1DF7-41D8-B201-DCA6641A92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5969F5B-7D32-41E3-960E-067F1CCDFD75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feld 1"/>
          <p:cNvSpPr/>
          <p:nvPr/>
        </p:nvSpPr>
        <p:spPr>
          <a:xfrm>
            <a:off x="2411280" y="612720"/>
            <a:ext cx="5689800" cy="36828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1,010 patients treated in FinHER tria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feld 4"/>
          <p:cNvSpPr/>
          <p:nvPr/>
        </p:nvSpPr>
        <p:spPr>
          <a:xfrm>
            <a:off x="2411280" y="3133800"/>
            <a:ext cx="5724720" cy="36828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In 882 patients successfull CXCL13 mRNA analysi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feld 11"/>
          <p:cNvSpPr/>
          <p:nvPr/>
        </p:nvSpPr>
        <p:spPr>
          <a:xfrm>
            <a:off x="3261240" y="1225440"/>
            <a:ext cx="4504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In 60 patients no suitable tumor tissue retrieved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Gerade Verbindung 13"/>
          <p:cNvSpPr/>
          <p:nvPr/>
        </p:nvSpPr>
        <p:spPr>
          <a:xfrm>
            <a:off x="3228840" y="981000"/>
            <a:ext cx="0" cy="885960"/>
          </a:xfrm>
          <a:prstGeom prst="line">
            <a:avLst/>
          </a:prstGeom>
          <a:ln w="381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Gerade Verbindung 6"/>
          <p:cNvSpPr/>
          <p:nvPr/>
        </p:nvSpPr>
        <p:spPr>
          <a:xfrm>
            <a:off x="3244680" y="3502080"/>
            <a:ext cx="0" cy="885600"/>
          </a:xfrm>
          <a:prstGeom prst="line">
            <a:avLst/>
          </a:prstGeom>
          <a:ln w="381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feld 4"/>
          <p:cNvSpPr/>
          <p:nvPr/>
        </p:nvSpPr>
        <p:spPr>
          <a:xfrm>
            <a:off x="2411280" y="4437000"/>
            <a:ext cx="5718240" cy="36828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In 876 patients successfull CD4 mRNA analysi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Gerade Verbindung 9"/>
          <p:cNvSpPr/>
          <p:nvPr/>
        </p:nvSpPr>
        <p:spPr>
          <a:xfrm>
            <a:off x="3244680" y="4834080"/>
            <a:ext cx="0" cy="885600"/>
          </a:xfrm>
          <a:prstGeom prst="line">
            <a:avLst/>
          </a:prstGeom>
          <a:ln w="381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feld 4"/>
          <p:cNvSpPr/>
          <p:nvPr/>
        </p:nvSpPr>
        <p:spPr>
          <a:xfrm>
            <a:off x="2411280" y="5764320"/>
            <a:ext cx="5724720" cy="36828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In 874 patients successfull FOXP3 mRNA analysi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Rechteck 1"/>
          <p:cNvSpPr/>
          <p:nvPr/>
        </p:nvSpPr>
        <p:spPr>
          <a:xfrm>
            <a:off x="3244680" y="3760920"/>
            <a:ext cx="5318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In 6 patients CD4 mRNA analysis not successful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hteck 11"/>
          <p:cNvSpPr/>
          <p:nvPr/>
        </p:nvSpPr>
        <p:spPr>
          <a:xfrm>
            <a:off x="3224160" y="5027760"/>
            <a:ext cx="5668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In 2 patients FOXP3 mRNA analysis not successfull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feld 4"/>
          <p:cNvSpPr/>
          <p:nvPr/>
        </p:nvSpPr>
        <p:spPr>
          <a:xfrm>
            <a:off x="2411280" y="1879560"/>
            <a:ext cx="5724720" cy="36828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In 950 patients tumor tissue availabl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Gerade Verbindung 14"/>
          <p:cNvSpPr/>
          <p:nvPr/>
        </p:nvSpPr>
        <p:spPr>
          <a:xfrm>
            <a:off x="3228840" y="2247840"/>
            <a:ext cx="0" cy="885960"/>
          </a:xfrm>
          <a:prstGeom prst="line">
            <a:avLst/>
          </a:prstGeom>
          <a:ln w="381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feld 11"/>
          <p:cNvSpPr/>
          <p:nvPr/>
        </p:nvSpPr>
        <p:spPr>
          <a:xfrm>
            <a:off x="3257280" y="2506680"/>
            <a:ext cx="336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In 68 patients RNA extraction faile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2-12T13:27:14Z</dcterms:created>
  <dc:creator>Schmidt, Marcus</dc:creator>
  <dc:description/>
  <dc:language>en-US</dc:language>
  <cp:lastModifiedBy>Schmidt, Marcus</cp:lastModifiedBy>
  <dcterms:modified xsi:type="dcterms:W3CDTF">2017-11-01T10:45:41Z</dcterms:modified>
  <cp:revision>18</cp:revision>
  <dc:subject/>
  <dc:title>PowerPoint-Präsentation</dc:title>
</cp:coreProperties>
</file>